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68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5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264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0C4355-8C6B-7226-E49B-6C2D859CBCF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3D20F4D-1EE8-F49F-812F-B80EB1D46C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CAC2B9-7C90-2257-585A-19EB69D49C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40BE9-37B3-44F4-85ED-4C855E5E66FC}" type="datetimeFigureOut">
              <a:rPr lang="en-GB" smtClean="0"/>
              <a:t>16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F99488-8483-F0D1-185B-F0CCFE06AA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254BA5-7BA6-010A-C62B-F78C8B7CC3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3AD8F-D3B0-4CDA-B3D0-070FAD9F70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56160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657D0A-6F31-6B3B-E910-66A5A0ECAF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FA3F206-EEFA-5D7E-4DD9-9F628A9290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5A3684-B45C-C9D3-08A2-2487F6EEC0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40BE9-37B3-44F4-85ED-4C855E5E66FC}" type="datetimeFigureOut">
              <a:rPr lang="en-GB" smtClean="0"/>
              <a:t>16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33AC8B-750E-FCB6-3CDE-F6F035314B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076457-C615-623F-6F3A-32A9860D4B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3AD8F-D3B0-4CDA-B3D0-070FAD9F70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67864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E03F374-9FDB-0CC9-F216-4A96AF2FD7E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53D4EEE-410F-E8D2-DE7E-7048568424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89C4D0-F3BD-C4B2-FC7D-8FCC8773E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40BE9-37B3-44F4-85ED-4C855E5E66FC}" type="datetimeFigureOut">
              <a:rPr lang="en-GB" smtClean="0"/>
              <a:t>16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B92CA2-C9AF-D979-951A-ED8B500054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D97690-C593-E15C-B91D-89FAED234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3AD8F-D3B0-4CDA-B3D0-070FAD9F70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4573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A1BDB8-4D26-B75F-F562-B7A76057BA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377A30-C7FE-E1AB-0369-D234E8350D8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80D06E-4D57-3FCE-982A-DD19847F38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40BE9-37B3-44F4-85ED-4C855E5E66FC}" type="datetimeFigureOut">
              <a:rPr lang="en-GB" smtClean="0"/>
              <a:t>16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85EBE8-BDEB-A458-5339-19C3325033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ED22FB-DC9E-93D5-7BC4-1D27D66FAD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3AD8F-D3B0-4CDA-B3D0-070FAD9F70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70673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726677-322A-7998-F12C-E48EB7E386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7E6844-A64F-05E5-B506-ACD0EEF2AF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9E730C-B919-5ADE-296D-2610A646BB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40BE9-37B3-44F4-85ED-4C855E5E66FC}" type="datetimeFigureOut">
              <a:rPr lang="en-GB" smtClean="0"/>
              <a:t>16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52C3F5-0D23-AB37-AA36-51F808E59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0ECB38-4C8B-8410-C129-D44271D6AE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3AD8F-D3B0-4CDA-B3D0-070FAD9F70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46305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50BFEC-A0B8-DDB1-BF4B-DFF2D6AED3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4AA5CA-B292-CD42-EC66-53FAF7E2695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AB56D2A-4DB9-EE69-1593-59195F880D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4E03F87-0438-AA6E-3763-81AFBDE159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40BE9-37B3-44F4-85ED-4C855E5E66FC}" type="datetimeFigureOut">
              <a:rPr lang="en-GB" smtClean="0"/>
              <a:t>16/08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208D48-6246-E152-7A78-63B989CBB1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A93979-4B81-A3B0-3C5E-A3CD7EA9AB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3AD8F-D3B0-4CDA-B3D0-070FAD9F70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60508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1A3E6E-51F8-7702-66B2-E40C7A0D96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56D095-B273-6F0C-7896-E257A95E9B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7C7BB19-802F-FBE7-3239-5BC2A53358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A13AC39-9430-76CA-3ABE-5641D606BAB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D4A0546-B4C4-B73A-2EA4-4A5BD542D7D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CB2CA0A-CD5F-E46A-CFC0-7727B2DD8B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40BE9-37B3-44F4-85ED-4C855E5E66FC}" type="datetimeFigureOut">
              <a:rPr lang="en-GB" smtClean="0"/>
              <a:t>16/08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51C3C28-7BBF-0497-98F6-B0E08A3070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F2CA95E-2C9C-3736-A356-7883798F4C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3AD8F-D3B0-4CDA-B3D0-070FAD9F70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59305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B1A5EE-3E27-B862-39B5-CE9CE8E66B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F94B68A-DF70-06E6-4973-E3BF0518B0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40BE9-37B3-44F4-85ED-4C855E5E66FC}" type="datetimeFigureOut">
              <a:rPr lang="en-GB" smtClean="0"/>
              <a:t>16/08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B17998E-EBA9-3DB5-7D6E-0B4F4C2BA0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C1BF211-A8D8-2528-2878-CC48CB7C6A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3AD8F-D3B0-4CDA-B3D0-070FAD9F70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16154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5C1AB41-BCCD-82CC-C054-E5D57444AA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40BE9-37B3-44F4-85ED-4C855E5E66FC}" type="datetimeFigureOut">
              <a:rPr lang="en-GB" smtClean="0"/>
              <a:t>16/08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D295A18-1E7F-AFAD-6B80-CAAA79E5E7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9E4D687-A15A-5C15-2251-C983D8468A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3AD8F-D3B0-4CDA-B3D0-070FAD9F70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98870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4A582F-8318-D2FE-3C5C-BB21FD623C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69BEAD-64D3-5C40-1EA3-EFEF2945B9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8225790-F9B4-160D-1A94-08F9FC999B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353EBFE-8C37-6030-B32D-19B194D758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40BE9-37B3-44F4-85ED-4C855E5E66FC}" type="datetimeFigureOut">
              <a:rPr lang="en-GB" smtClean="0"/>
              <a:t>16/08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BEBC2AB-325C-1BEC-0763-A9F9CC3D8B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7ABF17-EE08-CB0E-2F76-EE55ADE18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3AD8F-D3B0-4CDA-B3D0-070FAD9F70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63122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371A34-EF11-1F24-14F6-5B96F1C6A9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89539E4-6414-8190-24EF-E3E4ADE016E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29B8507-3248-5546-B58B-7EE6777CC0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85988A-1479-8062-5937-59E7B52758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40BE9-37B3-44F4-85ED-4C855E5E66FC}" type="datetimeFigureOut">
              <a:rPr lang="en-GB" smtClean="0"/>
              <a:t>16/08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FFF28B-C168-A835-2464-797404B18F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72DC79-21E2-111D-57DD-2FB0AF4F48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3AD8F-D3B0-4CDA-B3D0-070FAD9F70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90966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03D14D4-DE0E-8E68-D33F-1A652BDECE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BDAA88-2E23-A30C-6993-C3E195604F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43425B-0C4A-A997-26A0-CB62D18934B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E40BE9-37B3-44F4-85ED-4C855E5E66FC}" type="datetimeFigureOut">
              <a:rPr lang="en-GB" smtClean="0"/>
              <a:t>16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88CEE8-4F0E-AD70-3B9B-1BD68BDBCD9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91168E-F8DC-4181-5331-FA846D50FB6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93AD8F-D3B0-4CDA-B3D0-070FAD9F70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24777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>
            <a:extLst>
              <a:ext uri="{FF2B5EF4-FFF2-40B4-BE49-F238E27FC236}">
                <a16:creationId xmlns:a16="http://schemas.microsoft.com/office/drawing/2014/main" id="{BFF1275E-8A88-D1AB-EC17-9737246BFB72}"/>
              </a:ext>
            </a:extLst>
          </p:cNvPr>
          <p:cNvSpPr txBox="1"/>
          <p:nvPr/>
        </p:nvSpPr>
        <p:spPr>
          <a:xfrm>
            <a:off x="798274" y="1814493"/>
            <a:ext cx="1048857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-1: Western blot used to produce Fig 1a is shown in full. This also includes positive control samples prepared from mouse testis, which are known to express Brn-3b proteins ().</a:t>
            </a:r>
            <a:r>
              <a:rPr lang="en-GB" sz="1200" dirty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en-GB" sz="1200" dirty="0">
                <a:solidFill>
                  <a:srgbClr val="000000"/>
                </a:solidFill>
                <a:highlight>
                  <a:srgbClr val="FFFF00"/>
                </a:highlight>
                <a:latin typeface="Arial" panose="020B0604020202020204" pitchFamily="34" charset="0"/>
              </a:rPr>
              <a:t>Please note that the testes positive control expressed higher levels of the longer Brn-3b(l) isoform while the shorter Brn-3b(s) is the only isoform expressed in aortic tissue.</a:t>
            </a:r>
            <a:r>
              <a:rPr lang="en-GB" sz="1200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solidFill>
                  <a:srgbClr val="000000"/>
                </a:solidFill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WB data showing </a:t>
            </a:r>
            <a:r>
              <a:rPr lang="en-GB" sz="1200" dirty="0">
                <a:solidFill>
                  <a:srgbClr val="000000"/>
                </a:solidFill>
                <a:highlight>
                  <a:srgbClr val="FFFF00"/>
                </a:highlight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GB" sz="1200" dirty="0">
                <a:solidFill>
                  <a:srgbClr val="000000"/>
                </a:solidFill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-tubulin p</a:t>
            </a:r>
            <a:r>
              <a:rPr lang="en-GB" sz="1200" dirty="0">
                <a:solidFill>
                  <a:srgbClr val="000000"/>
                </a:solidFill>
                <a:highlight>
                  <a:srgbClr val="FFFF00"/>
                </a:highlight>
                <a:latin typeface="Arial" panose="020B0604020202020204" pitchFamily="34" charset="0"/>
              </a:rPr>
              <a:t>rotein was used to show variation in total protein in different samples used.</a:t>
            </a:r>
            <a:endParaRPr lang="en-GB" sz="1200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0" name="Group 39">
            <a:extLst>
              <a:ext uri="{FF2B5EF4-FFF2-40B4-BE49-F238E27FC236}">
                <a16:creationId xmlns:a16="http://schemas.microsoft.com/office/drawing/2014/main" id="{B9703F63-0E44-6C93-F192-77193D4AC36C}"/>
              </a:ext>
            </a:extLst>
          </p:cNvPr>
          <p:cNvGrpSpPr/>
          <p:nvPr/>
        </p:nvGrpSpPr>
        <p:grpSpPr>
          <a:xfrm>
            <a:off x="2166568" y="2722671"/>
            <a:ext cx="3312367" cy="3219061"/>
            <a:chOff x="2062065" y="1651517"/>
            <a:chExt cx="3312367" cy="3219061"/>
          </a:xfrm>
        </p:grpSpPr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4A8368D3-7F98-3F0D-25F9-31485F628F7C}"/>
                </a:ext>
              </a:extLst>
            </p:cNvPr>
            <p:cNvGrpSpPr/>
            <p:nvPr/>
          </p:nvGrpSpPr>
          <p:grpSpPr>
            <a:xfrm>
              <a:off x="2062065" y="1651517"/>
              <a:ext cx="3312367" cy="3219061"/>
              <a:chOff x="2062065" y="1651517"/>
              <a:chExt cx="3312367" cy="3219061"/>
            </a:xfrm>
          </p:grpSpPr>
          <p:grpSp>
            <p:nvGrpSpPr>
              <p:cNvPr id="26" name="Group 25">
                <a:extLst>
                  <a:ext uri="{FF2B5EF4-FFF2-40B4-BE49-F238E27FC236}">
                    <a16:creationId xmlns:a16="http://schemas.microsoft.com/office/drawing/2014/main" id="{5895BC59-9DA0-78D6-1274-56730576A57A}"/>
                  </a:ext>
                </a:extLst>
              </p:cNvPr>
              <p:cNvGrpSpPr/>
              <p:nvPr/>
            </p:nvGrpSpPr>
            <p:grpSpPr>
              <a:xfrm>
                <a:off x="2062065" y="1651517"/>
                <a:ext cx="3312367" cy="3219061"/>
                <a:chOff x="6960637" y="522514"/>
                <a:chExt cx="3312367" cy="3219061"/>
              </a:xfrm>
            </p:grpSpPr>
            <p:pic>
              <p:nvPicPr>
                <p:cNvPr id="18" name="Picture 17">
                  <a:extLst>
                    <a:ext uri="{FF2B5EF4-FFF2-40B4-BE49-F238E27FC236}">
                      <a16:creationId xmlns:a16="http://schemas.microsoft.com/office/drawing/2014/main" id="{26328B57-067C-F010-96F6-4380232B49A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bright="-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369" t="37490" r="48853" b="-893"/>
                <a:stretch/>
              </p:blipFill>
              <p:spPr>
                <a:xfrm>
                  <a:off x="6960637" y="522514"/>
                  <a:ext cx="3312367" cy="3219061"/>
                </a:xfrm>
                <a:prstGeom prst="rect">
                  <a:avLst/>
                </a:prstGeom>
              </p:spPr>
            </p:pic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D7D422AD-9B77-7CF9-F590-7698A7FE16B2}"/>
                    </a:ext>
                  </a:extLst>
                </p:cNvPr>
                <p:cNvSpPr txBox="1"/>
                <p:nvPr/>
              </p:nvSpPr>
              <p:spPr>
                <a:xfrm>
                  <a:off x="6979296" y="2911152"/>
                  <a:ext cx="7633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/>
                    <a:t> 33 </a:t>
                  </a:r>
                  <a:r>
                    <a:rPr lang="en-GB" sz="1200" dirty="0" err="1"/>
                    <a:t>kDa</a:t>
                  </a:r>
                  <a:r>
                    <a:rPr lang="en-GB" sz="1200" dirty="0"/>
                    <a:t> &gt;</a:t>
                  </a: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4FA58AAC-60E0-8FAF-CCF0-D6FE80C49D26}"/>
                    </a:ext>
                  </a:extLst>
                </p:cNvPr>
                <p:cNvSpPr txBox="1"/>
                <p:nvPr/>
              </p:nvSpPr>
              <p:spPr>
                <a:xfrm>
                  <a:off x="8892753" y="833685"/>
                  <a:ext cx="746662" cy="553998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rn 3b</a:t>
                  </a:r>
                </a:p>
                <a:p>
                  <a:pPr algn="ctr"/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O </a:t>
                  </a:r>
                </a:p>
                <a:p>
                  <a:pPr algn="ctr"/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orta 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7D809CE8-84F3-1478-ED18-40FB012ECA2B}"/>
                    </a:ext>
                  </a:extLst>
                </p:cNvPr>
                <p:cNvSpPr txBox="1"/>
                <p:nvPr/>
              </p:nvSpPr>
              <p:spPr>
                <a:xfrm>
                  <a:off x="7594655" y="1129178"/>
                  <a:ext cx="1268057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rmal WT </a:t>
                  </a:r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orta</a:t>
                  </a:r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9E15149A-37D5-C096-A1DF-E695017B1A2A}"/>
                    </a:ext>
                  </a:extLst>
                </p:cNvPr>
                <p:cNvSpPr txBox="1"/>
                <p:nvPr/>
              </p:nvSpPr>
              <p:spPr>
                <a:xfrm>
                  <a:off x="8340278" y="563322"/>
                  <a:ext cx="82907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b="1" u="sng" dirty="0">
                      <a:cs typeface="Arial" panose="020B0604020202020204" pitchFamily="34" charset="0"/>
                    </a:rPr>
                    <a:t>Brn-3b Ab</a:t>
                  </a:r>
                  <a:endParaRPr lang="en-US" sz="1200" b="1" u="sng" dirty="0"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FFC4F61E-B2BE-FA76-DDCA-55014025C35B}"/>
                  </a:ext>
                </a:extLst>
              </p:cNvPr>
              <p:cNvSpPr txBox="1"/>
              <p:nvPr/>
            </p:nvSpPr>
            <p:spPr>
              <a:xfrm>
                <a:off x="4525348" y="1912776"/>
                <a:ext cx="821094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/>
                  <a:t>+</a:t>
                </a:r>
                <a:r>
                  <a:rPr lang="en-GB" sz="1200" b="1" dirty="0" err="1"/>
                  <a:t>ve</a:t>
                </a:r>
                <a:r>
                  <a:rPr lang="en-GB" sz="1200" b="1" dirty="0"/>
                  <a:t> controls (testis)</a:t>
                </a:r>
              </a:p>
            </p:txBody>
          </p:sp>
        </p:grpSp>
        <p:sp>
          <p:nvSpPr>
            <p:cNvPr id="34" name="Right Brace 33">
              <a:extLst>
                <a:ext uri="{FF2B5EF4-FFF2-40B4-BE49-F238E27FC236}">
                  <a16:creationId xmlns:a16="http://schemas.microsoft.com/office/drawing/2014/main" id="{FE6717B4-382E-49AE-6953-DED3A9E9AC7B}"/>
                </a:ext>
              </a:extLst>
            </p:cNvPr>
            <p:cNvSpPr/>
            <p:nvPr/>
          </p:nvSpPr>
          <p:spPr>
            <a:xfrm rot="16200000">
              <a:off x="4869042" y="2265800"/>
              <a:ext cx="199021" cy="606488"/>
            </a:xfrm>
            <a:prstGeom prst="righ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5" name="Right Brace 34">
              <a:extLst>
                <a:ext uri="{FF2B5EF4-FFF2-40B4-BE49-F238E27FC236}">
                  <a16:creationId xmlns:a16="http://schemas.microsoft.com/office/drawing/2014/main" id="{9D28B0A0-89F2-82C9-B298-1556E8D3BCED}"/>
                </a:ext>
              </a:extLst>
            </p:cNvPr>
            <p:cNvSpPr/>
            <p:nvPr/>
          </p:nvSpPr>
          <p:spPr>
            <a:xfrm rot="16200000">
              <a:off x="3270398" y="2029423"/>
              <a:ext cx="167919" cy="998376"/>
            </a:xfrm>
            <a:prstGeom prst="righ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6" name="Right Brace 35">
              <a:extLst>
                <a:ext uri="{FF2B5EF4-FFF2-40B4-BE49-F238E27FC236}">
                  <a16:creationId xmlns:a16="http://schemas.microsoft.com/office/drawing/2014/main" id="{5368FDBF-F16B-4085-96D1-BC07AD6068C2}"/>
                </a:ext>
              </a:extLst>
            </p:cNvPr>
            <p:cNvSpPr/>
            <p:nvPr/>
          </p:nvSpPr>
          <p:spPr>
            <a:xfrm rot="16200000">
              <a:off x="4274979" y="2399522"/>
              <a:ext cx="205273" cy="314130"/>
            </a:xfrm>
            <a:prstGeom prst="righ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41" name="Group 40">
            <a:extLst>
              <a:ext uri="{FF2B5EF4-FFF2-40B4-BE49-F238E27FC236}">
                <a16:creationId xmlns:a16="http://schemas.microsoft.com/office/drawing/2014/main" id="{E18DBFE2-DC9D-1D62-9A0C-D73B4D68AE75}"/>
              </a:ext>
            </a:extLst>
          </p:cNvPr>
          <p:cNvGrpSpPr/>
          <p:nvPr/>
        </p:nvGrpSpPr>
        <p:grpSpPr>
          <a:xfrm>
            <a:off x="5665550" y="2704010"/>
            <a:ext cx="3452326" cy="3256384"/>
            <a:chOff x="5561047" y="1632856"/>
            <a:chExt cx="3452326" cy="3256384"/>
          </a:xfrm>
        </p:grpSpPr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20A16AB3-8811-5105-E9CC-620075D6A58A}"/>
                </a:ext>
              </a:extLst>
            </p:cNvPr>
            <p:cNvGrpSpPr/>
            <p:nvPr/>
          </p:nvGrpSpPr>
          <p:grpSpPr>
            <a:xfrm>
              <a:off x="5561047" y="1632856"/>
              <a:ext cx="3452326" cy="3256384"/>
              <a:chOff x="5561047" y="1632856"/>
              <a:chExt cx="3452326" cy="3256384"/>
            </a:xfrm>
          </p:grpSpPr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7C5C2244-2826-5892-EA10-C3D94132679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333" t="-612" r="36163" b="41672"/>
              <a:stretch/>
            </p:blipFill>
            <p:spPr>
              <a:xfrm>
                <a:off x="5561047" y="1632856"/>
                <a:ext cx="3452326" cy="3256384"/>
              </a:xfrm>
              <a:prstGeom prst="rect">
                <a:avLst/>
              </a:prstGeom>
            </p:spPr>
          </p:pic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042C2D26-2C56-8D41-5D0F-B86E69F01492}"/>
                  </a:ext>
                </a:extLst>
              </p:cNvPr>
              <p:cNvSpPr txBox="1"/>
              <p:nvPr/>
            </p:nvSpPr>
            <p:spPr>
              <a:xfrm>
                <a:off x="5612365" y="2428703"/>
                <a:ext cx="7633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 55 </a:t>
                </a:r>
                <a:r>
                  <a:rPr lang="en-GB" sz="1200" dirty="0" err="1"/>
                  <a:t>kDa</a:t>
                </a:r>
                <a:r>
                  <a:rPr lang="en-GB" sz="1200" dirty="0"/>
                  <a:t> &gt;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57ACC64C-BDA0-D07D-90B3-B4D0FD934B34}"/>
                  </a:ext>
                </a:extLst>
              </p:cNvPr>
              <p:cNvSpPr txBox="1"/>
              <p:nvPr/>
            </p:nvSpPr>
            <p:spPr>
              <a:xfrm>
                <a:off x="6768629" y="1675731"/>
                <a:ext cx="99097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u="sng" dirty="0">
                    <a:latin typeface="Symbol" panose="05050102010706020507" pitchFamily="18" charset="2"/>
                    <a:cs typeface="Arial" panose="020B0604020202020204" pitchFamily="34" charset="0"/>
                  </a:rPr>
                  <a:t>b</a:t>
                </a:r>
                <a:r>
                  <a:rPr lang="en-GB" sz="1200" b="1" u="sng" dirty="0">
                    <a:cs typeface="Arial" panose="020B0604020202020204" pitchFamily="34" charset="0"/>
                  </a:rPr>
                  <a:t>-tubulin Ab</a:t>
                </a:r>
                <a:endParaRPr lang="en-US" sz="1200" b="1" u="sng" dirty="0">
                  <a:cs typeface="Arial" panose="020B0604020202020204" pitchFamily="34" charset="0"/>
                </a:endParaRP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79D6E310-B88C-B9C9-E8DB-2FC676365DCD}"/>
                  </a:ext>
                </a:extLst>
              </p:cNvPr>
              <p:cNvSpPr txBox="1"/>
              <p:nvPr/>
            </p:nvSpPr>
            <p:spPr>
              <a:xfrm>
                <a:off x="7328320" y="1919144"/>
                <a:ext cx="746662" cy="55399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rn 3b</a:t>
                </a:r>
              </a:p>
              <a:p>
                <a:pPr algn="ct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KO </a:t>
                </a:r>
              </a:p>
              <a:p>
                <a:pPr algn="ct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orta 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7DAF1431-2475-D995-6CF5-100431FA4367}"/>
                  </a:ext>
                </a:extLst>
              </p:cNvPr>
              <p:cNvSpPr txBox="1"/>
              <p:nvPr/>
            </p:nvSpPr>
            <p:spPr>
              <a:xfrm>
                <a:off x="6272817" y="2167985"/>
                <a:ext cx="1268057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 WT </a:t>
                </a:r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orta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29D4C839-2320-5ADC-A22F-56EAEBE60BC6}"/>
                  </a:ext>
                </a:extLst>
              </p:cNvPr>
              <p:cNvSpPr txBox="1"/>
              <p:nvPr/>
            </p:nvSpPr>
            <p:spPr>
              <a:xfrm>
                <a:off x="7887478" y="1971869"/>
                <a:ext cx="989045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/>
                  <a:t>+</a:t>
                </a:r>
                <a:r>
                  <a:rPr lang="en-GB" sz="1200" b="1" dirty="0" err="1"/>
                  <a:t>ve</a:t>
                </a:r>
                <a:r>
                  <a:rPr lang="en-GB" sz="1200" b="1" dirty="0"/>
                  <a:t> controls (testis)</a:t>
                </a:r>
              </a:p>
            </p:txBody>
          </p:sp>
        </p:grpSp>
        <p:sp>
          <p:nvSpPr>
            <p:cNvPr id="37" name="Right Brace 36">
              <a:extLst>
                <a:ext uri="{FF2B5EF4-FFF2-40B4-BE49-F238E27FC236}">
                  <a16:creationId xmlns:a16="http://schemas.microsoft.com/office/drawing/2014/main" id="{F7F00990-0C0A-224E-D569-E503958439F2}"/>
                </a:ext>
              </a:extLst>
            </p:cNvPr>
            <p:cNvSpPr/>
            <p:nvPr/>
          </p:nvSpPr>
          <p:spPr>
            <a:xfrm rot="16200000">
              <a:off x="8217178" y="2102514"/>
              <a:ext cx="177250" cy="712235"/>
            </a:xfrm>
            <a:prstGeom prst="righ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8" name="Right Brace 37">
              <a:extLst>
                <a:ext uri="{FF2B5EF4-FFF2-40B4-BE49-F238E27FC236}">
                  <a16:creationId xmlns:a16="http://schemas.microsoft.com/office/drawing/2014/main" id="{8A1008E4-80A8-633D-0CAF-517AB4D7E08D}"/>
                </a:ext>
              </a:extLst>
            </p:cNvPr>
            <p:cNvSpPr/>
            <p:nvPr/>
          </p:nvSpPr>
          <p:spPr>
            <a:xfrm rot="16200000">
              <a:off x="6777155" y="1903455"/>
              <a:ext cx="211462" cy="1132124"/>
            </a:xfrm>
            <a:prstGeom prst="righ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9" name="Right Brace 38">
              <a:extLst>
                <a:ext uri="{FF2B5EF4-FFF2-40B4-BE49-F238E27FC236}">
                  <a16:creationId xmlns:a16="http://schemas.microsoft.com/office/drawing/2014/main" id="{0D40BFBC-DF1C-E13B-9325-AB6D30A09B44}"/>
                </a:ext>
              </a:extLst>
            </p:cNvPr>
            <p:cNvSpPr/>
            <p:nvPr/>
          </p:nvSpPr>
          <p:spPr>
            <a:xfrm rot="16200000">
              <a:off x="7590456" y="2299995"/>
              <a:ext cx="205273" cy="314130"/>
            </a:xfrm>
            <a:prstGeom prst="righ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039D2F1C-FFDA-54DC-A521-323B63179B8E}"/>
              </a:ext>
            </a:extLst>
          </p:cNvPr>
          <p:cNvSpPr txBox="1"/>
          <p:nvPr/>
        </p:nvSpPr>
        <p:spPr>
          <a:xfrm>
            <a:off x="4495528" y="1375954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solidFill>
                  <a:srgbClr val="000000"/>
                </a:solidFill>
                <a:latin typeface="Arial" panose="020B0604020202020204" pitchFamily="34" charset="0"/>
              </a:rPr>
              <a:t>Supplementary data S1:</a:t>
            </a:r>
            <a:endParaRPr lang="en-GB" sz="1400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85E601B-F70C-B803-6E50-65F4809EDB08}"/>
              </a:ext>
            </a:extLst>
          </p:cNvPr>
          <p:cNvSpPr txBox="1"/>
          <p:nvPr/>
        </p:nvSpPr>
        <p:spPr>
          <a:xfrm>
            <a:off x="4667796" y="191589"/>
            <a:ext cx="24122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ORIGINAL DATA FILES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18178565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</TotalTime>
  <Words>130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hadeo, Vishwanie</dc:creator>
  <cp:lastModifiedBy>Mahadeo, Vishwanie</cp:lastModifiedBy>
  <cp:revision>5</cp:revision>
  <dcterms:created xsi:type="dcterms:W3CDTF">2023-06-19T11:42:58Z</dcterms:created>
  <dcterms:modified xsi:type="dcterms:W3CDTF">2023-08-16T09:34:49Z</dcterms:modified>
</cp:coreProperties>
</file>